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7B59F-E122-4066-8639-AE7EC20ABC8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139B67-872C-47CE-8ACE-A631327DFF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D2357-9AC2-45CA-A76A-2EEE2A61AF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AE7612-00F1-424C-958C-014A6A2DBF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7DE6F-ED19-4942-B150-2BAB5B1D012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C44072-7A65-4AA0-A66D-4245405252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89997-8BB1-4D81-9325-3B46AFECA4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A3762-4110-498B-870D-9920A9CD90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9A93D8-99A4-43CA-ABAD-BEDA268112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A65FAD-5950-4EFE-8482-7E675860DCF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184E6-7EB2-4B87-A51A-0F646A94F5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CC10B-8159-4C90-9520-ED933DF34E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12068F-0BBC-44B1-853E-265039F91B4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1"/>
          <p:cNvSpPr/>
          <p:nvPr/>
        </p:nvSpPr>
        <p:spPr>
          <a:xfrm>
            <a:off x="2411280" y="993600"/>
            <a:ext cx="598176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595 patients treated in HE10/97 tria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feld 4"/>
          <p:cNvSpPr/>
          <p:nvPr/>
        </p:nvSpPr>
        <p:spPr>
          <a:xfrm>
            <a:off x="2411280" y="2205000"/>
            <a:ext cx="598176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 366 patients tumor tissue and clinical data retrieved  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feld 11"/>
          <p:cNvSpPr/>
          <p:nvPr/>
        </p:nvSpPr>
        <p:spPr>
          <a:xfrm>
            <a:off x="3192120" y="1619280"/>
            <a:ext cx="385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n 229 patients no tumor tissue retrieved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Gerade Verbindung 13"/>
          <p:cNvSpPr/>
          <p:nvPr/>
        </p:nvSpPr>
        <p:spPr>
          <a:xfrm>
            <a:off x="3168720" y="1362240"/>
            <a:ext cx="0" cy="88560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Gerade Verbindung 6"/>
          <p:cNvSpPr/>
          <p:nvPr/>
        </p:nvSpPr>
        <p:spPr>
          <a:xfrm>
            <a:off x="3168720" y="2573280"/>
            <a:ext cx="0" cy="88596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feld 4"/>
          <p:cNvSpPr/>
          <p:nvPr/>
        </p:nvSpPr>
        <p:spPr>
          <a:xfrm>
            <a:off x="2411280" y="3459240"/>
            <a:ext cx="598176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47 patients triple-negativ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Gerade Verbindung 9"/>
          <p:cNvSpPr/>
          <p:nvPr/>
        </p:nvSpPr>
        <p:spPr>
          <a:xfrm>
            <a:off x="3178080" y="3828960"/>
            <a:ext cx="0" cy="885960"/>
          </a:xfrm>
          <a:prstGeom prst="line">
            <a:avLst/>
          </a:prstGeom>
          <a:ln w="38160">
            <a:solidFill>
              <a:srgbClr val="4a7eb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feld 4"/>
          <p:cNvSpPr/>
          <p:nvPr/>
        </p:nvSpPr>
        <p:spPr>
          <a:xfrm>
            <a:off x="2411280" y="4751280"/>
            <a:ext cx="5981760" cy="36828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  <a:ea typeface="Arial"/>
              </a:rPr>
              <a:t>In 38 patients successfull CXCL13 mRNA analysi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feld 11"/>
          <p:cNvSpPr/>
          <p:nvPr/>
        </p:nvSpPr>
        <p:spPr>
          <a:xfrm>
            <a:off x="3185640" y="2832120"/>
            <a:ext cx="3624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319 patients luminal or HER2 positive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feld 12"/>
          <p:cNvSpPr/>
          <p:nvPr/>
        </p:nvSpPr>
        <p:spPr>
          <a:xfrm>
            <a:off x="3189960" y="4087800"/>
            <a:ext cx="3251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In 9 patients RNA extraction faile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2T13:27:14Z</dcterms:created>
  <dc:creator>Schmidt, Marcus</dc:creator>
  <dc:description/>
  <dc:language>en-US</dc:language>
  <cp:lastModifiedBy>Schmidt, Marcus</cp:lastModifiedBy>
  <dcterms:modified xsi:type="dcterms:W3CDTF">2017-11-01T10:45:02Z</dcterms:modified>
  <cp:revision>18</cp:revision>
  <dc:subject/>
  <dc:title>PowerPoint-Präsentation</dc:title>
</cp:coreProperties>
</file>